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480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-360"/>
            <a:ext cx="294480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39480" y="1240920"/>
            <a:ext cx="2514600" cy="3351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79720"/>
            <a:ext cx="5435640" cy="390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B5A698-BF8C-4020-B9E2-5593D60578C7}" type="slidenum">
              <a:rPr b="0" lang="fr-FR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sldImg"/>
          </p:nvPr>
        </p:nvSpPr>
        <p:spPr>
          <a:xfrm>
            <a:off x="2139840" y="1241280"/>
            <a:ext cx="2514600" cy="3351240"/>
          </a:xfrm>
          <a:prstGeom prst="rect">
            <a:avLst/>
          </a:prstGeom>
          <a:ln w="0">
            <a:noFill/>
          </a:ln>
        </p:spPr>
      </p:sp>
      <p:sp>
        <p:nvSpPr>
          <p:cNvPr id="187" name="PlaceHolder 2"/>
          <p:cNvSpPr>
            <a:spLocks noGrp="1"/>
          </p:cNvSpPr>
          <p:nvPr>
            <p:ph type="body"/>
          </p:nvPr>
        </p:nvSpPr>
        <p:spPr>
          <a:xfrm>
            <a:off x="678960" y="4779720"/>
            <a:ext cx="5435640" cy="39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Espace réservé du numéro de diapositive 3"/>
          <p:cNvSpPr/>
          <p:nvPr/>
        </p:nvSpPr>
        <p:spPr>
          <a:xfrm>
            <a:off x="3848040" y="9433080"/>
            <a:ext cx="2944800" cy="49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427DDA-511B-4008-851E-2C5D8CC47CE6}" type="slidenum">
              <a:rPr b="0" lang="fr-FR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4CD2E-5C16-4EBC-A864-9311C05DCE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6D2C0-B612-4BE8-943B-092027C5F8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F487D7-2568-44F2-B128-0F9AF1F5D7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F2AD2B-AA95-4E0A-98F4-29916B3623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8B4BF-7EAE-485E-B7B1-029E9FED46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C7509-9BBC-4344-8463-86FBFAF999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EB98E-7BF1-480C-AA24-A36855F73C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E3C4E-FC4B-4D0A-A693-CEE5B8EA51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131FD-696C-4D8F-A34E-CD36B053D1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63177-CDFB-43B9-B975-F742DD33C0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C4944-7088-4841-B9CB-C9AE1B7E31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A0720-540C-4A5F-92AD-B67DE7E735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BDBBF6-2E4F-47F1-9737-8454846F063C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1"/>
          <p:cNvGrpSpPr/>
          <p:nvPr/>
        </p:nvGrpSpPr>
        <p:grpSpPr>
          <a:xfrm>
            <a:off x="692280" y="301680"/>
            <a:ext cx="4824360" cy="8074440"/>
            <a:chOff x="692280" y="301680"/>
            <a:chExt cx="4824360" cy="8074440"/>
          </a:xfrm>
        </p:grpSpPr>
        <p:grpSp>
          <p:nvGrpSpPr>
            <p:cNvPr id="49" name="组合 75"/>
            <p:cNvGrpSpPr/>
            <p:nvPr/>
          </p:nvGrpSpPr>
          <p:grpSpPr>
            <a:xfrm>
              <a:off x="692280" y="301680"/>
              <a:ext cx="3697920" cy="2614680"/>
              <a:chOff x="692280" y="301680"/>
              <a:chExt cx="3697920" cy="2614680"/>
            </a:xfrm>
          </p:grpSpPr>
          <p:sp>
            <p:nvSpPr>
              <p:cNvPr id="50" name="ZoneTexte 12"/>
              <p:cNvSpPr/>
              <p:nvPr/>
            </p:nvSpPr>
            <p:spPr>
              <a:xfrm rot="19360800">
                <a:off x="1308960" y="509400"/>
                <a:ext cx="74772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ZoneTexte 20"/>
              <p:cNvSpPr/>
              <p:nvPr/>
            </p:nvSpPr>
            <p:spPr>
              <a:xfrm>
                <a:off x="693000" y="1862640"/>
                <a:ext cx="520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ZoneTexte 20"/>
              <p:cNvSpPr/>
              <p:nvPr/>
            </p:nvSpPr>
            <p:spPr>
              <a:xfrm>
                <a:off x="692280" y="178524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6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ZoneTexte 12"/>
              <p:cNvSpPr/>
              <p:nvPr/>
            </p:nvSpPr>
            <p:spPr>
              <a:xfrm rot="19360800">
                <a:off x="1799280" y="56880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9A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ZoneTexte 20"/>
              <p:cNvSpPr/>
              <p:nvPr/>
            </p:nvSpPr>
            <p:spPr>
              <a:xfrm>
                <a:off x="693000" y="195012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ZoneTexte 12"/>
              <p:cNvSpPr/>
              <p:nvPr/>
            </p:nvSpPr>
            <p:spPr>
              <a:xfrm rot="19360800">
                <a:off x="2052000" y="559080"/>
                <a:ext cx="587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9A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ZoneTexte 12"/>
              <p:cNvSpPr/>
              <p:nvPr/>
            </p:nvSpPr>
            <p:spPr>
              <a:xfrm rot="19360800">
                <a:off x="2289960" y="5637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9A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ZoneTexte 12"/>
              <p:cNvSpPr/>
              <p:nvPr/>
            </p:nvSpPr>
            <p:spPr>
              <a:xfrm rot="19360800">
                <a:off x="2466360" y="56880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11C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ZoneTexte 12"/>
              <p:cNvSpPr/>
              <p:nvPr/>
            </p:nvSpPr>
            <p:spPr>
              <a:xfrm rot="19360800">
                <a:off x="2682000" y="5637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15C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ZoneTexte 12"/>
              <p:cNvSpPr/>
              <p:nvPr/>
            </p:nvSpPr>
            <p:spPr>
              <a:xfrm rot="19360800">
                <a:off x="2898360" y="55908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43T&gt;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ZoneTexte 12"/>
              <p:cNvSpPr/>
              <p:nvPr/>
            </p:nvSpPr>
            <p:spPr>
              <a:xfrm rot="19360800">
                <a:off x="3114000" y="55908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43T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ZoneTexte 12"/>
              <p:cNvSpPr/>
              <p:nvPr/>
            </p:nvSpPr>
            <p:spPr>
              <a:xfrm rot="19360800">
                <a:off x="3330360" y="56088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43T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ZoneTexte 12"/>
              <p:cNvSpPr/>
              <p:nvPr/>
            </p:nvSpPr>
            <p:spPr>
              <a:xfrm rot="19360800">
                <a:off x="3613320" y="491400"/>
                <a:ext cx="74592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mpty vecto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3" name="图片 13" descr="文本&#10;&#10;低可信度描述已自动生成"/>
              <p:cNvPicPr/>
              <p:nvPr/>
            </p:nvPicPr>
            <p:blipFill>
              <a:blip r:embed="rId1"/>
              <a:srcRect l="8610" t="8333" r="11079" b="25558"/>
              <a:stretch/>
            </p:blipFill>
            <p:spPr>
              <a:xfrm>
                <a:off x="1079280" y="865800"/>
                <a:ext cx="3292920" cy="205056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64" name="Connecteur droit avec flèche 49"/>
              <p:cNvCxnSpPr/>
              <p:nvPr/>
            </p:nvCxnSpPr>
            <p:spPr>
              <a:xfrm flipH="1">
                <a:off x="2093400" y="191484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5" name="Connecteur droit avec flèche 49"/>
              <p:cNvCxnSpPr/>
              <p:nvPr/>
            </p:nvCxnSpPr>
            <p:spPr>
              <a:xfrm flipH="1">
                <a:off x="2329920" y="191304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6" name="Connecteur droit avec flèche 49"/>
              <p:cNvCxnSpPr/>
              <p:nvPr/>
            </p:nvCxnSpPr>
            <p:spPr>
              <a:xfrm flipH="1">
                <a:off x="2563200" y="190980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7" name="Connecteur droit avec flèche 49"/>
              <p:cNvCxnSpPr/>
              <p:nvPr/>
            </p:nvCxnSpPr>
            <p:spPr>
              <a:xfrm flipH="1">
                <a:off x="2783880" y="190692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8" name="Connecteur droit avec flèche 49"/>
              <p:cNvCxnSpPr/>
              <p:nvPr/>
            </p:nvCxnSpPr>
            <p:spPr>
              <a:xfrm flipH="1">
                <a:off x="3003120" y="191304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9" name="Connecteur droit avec flèche 49"/>
              <p:cNvCxnSpPr/>
              <p:nvPr/>
            </p:nvCxnSpPr>
            <p:spPr>
              <a:xfrm flipH="1">
                <a:off x="3234960" y="190692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70" name="Connecteur droit avec flèche 49"/>
              <p:cNvCxnSpPr/>
              <p:nvPr/>
            </p:nvCxnSpPr>
            <p:spPr>
              <a:xfrm flipH="1">
                <a:off x="1874160" y="191484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71" name="Connecteur droit avec flèche 49"/>
              <p:cNvCxnSpPr/>
              <p:nvPr/>
            </p:nvCxnSpPr>
            <p:spPr>
              <a:xfrm flipH="1">
                <a:off x="3452400" y="190980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72" name="Connecteur droit avec flèche 49"/>
              <p:cNvCxnSpPr/>
              <p:nvPr/>
            </p:nvCxnSpPr>
            <p:spPr>
              <a:xfrm flipH="1">
                <a:off x="3688920" y="190692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sp>
            <p:nvSpPr>
              <p:cNvPr id="73" name="ZoneTexte 12"/>
              <p:cNvSpPr/>
              <p:nvPr/>
            </p:nvSpPr>
            <p:spPr>
              <a:xfrm rot="19360800">
                <a:off x="1569600" y="554400"/>
                <a:ext cx="66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Wild-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4" name="组合 76"/>
            <p:cNvGrpSpPr/>
            <p:nvPr/>
          </p:nvGrpSpPr>
          <p:grpSpPr>
            <a:xfrm>
              <a:off x="765000" y="2919960"/>
              <a:ext cx="4751640" cy="2228040"/>
              <a:chOff x="765000" y="2919960"/>
              <a:chExt cx="4751640" cy="2228040"/>
            </a:xfrm>
          </p:grpSpPr>
          <p:sp>
            <p:nvSpPr>
              <p:cNvPr id="75" name="ZoneTexte 12"/>
              <p:cNvSpPr/>
              <p:nvPr/>
            </p:nvSpPr>
            <p:spPr>
              <a:xfrm rot="19360800">
                <a:off x="1603800" y="3119760"/>
                <a:ext cx="66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Wild-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ZoneTexte 12"/>
              <p:cNvSpPr/>
              <p:nvPr/>
            </p:nvSpPr>
            <p:spPr>
              <a:xfrm rot="19360800">
                <a:off x="1831680" y="312012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55G&gt;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ZoneTexte 12"/>
              <p:cNvSpPr/>
              <p:nvPr/>
            </p:nvSpPr>
            <p:spPr>
              <a:xfrm rot="19360800">
                <a:off x="2016720" y="31305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55G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ZoneTexte 12"/>
              <p:cNvSpPr/>
              <p:nvPr/>
            </p:nvSpPr>
            <p:spPr>
              <a:xfrm rot="19360800">
                <a:off x="2250000" y="31305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55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ZoneTexte 12"/>
              <p:cNvSpPr/>
              <p:nvPr/>
            </p:nvSpPr>
            <p:spPr>
              <a:xfrm rot="19360800">
                <a:off x="2467440" y="31496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56G&gt;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ZoneTexte 12"/>
              <p:cNvSpPr/>
              <p:nvPr/>
            </p:nvSpPr>
            <p:spPr>
              <a:xfrm rot="19360800">
                <a:off x="2694600" y="31244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56G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ZoneTexte 12"/>
              <p:cNvSpPr/>
              <p:nvPr/>
            </p:nvSpPr>
            <p:spPr>
              <a:xfrm rot="19360800">
                <a:off x="2931120" y="31496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56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ZoneTexte 12"/>
              <p:cNvSpPr/>
              <p:nvPr/>
            </p:nvSpPr>
            <p:spPr>
              <a:xfrm rot="19360800">
                <a:off x="3164400" y="31449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65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ZoneTexte 12"/>
              <p:cNvSpPr/>
              <p:nvPr/>
            </p:nvSpPr>
            <p:spPr>
              <a:xfrm rot="19360800">
                <a:off x="3385080" y="313560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0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ZoneTexte 12"/>
              <p:cNvSpPr/>
              <p:nvPr/>
            </p:nvSpPr>
            <p:spPr>
              <a:xfrm rot="19360800">
                <a:off x="3622320" y="3120480"/>
                <a:ext cx="745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mpty vecto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ZoneTexte 12"/>
              <p:cNvSpPr/>
              <p:nvPr/>
            </p:nvSpPr>
            <p:spPr>
              <a:xfrm rot="19360800">
                <a:off x="1335960" y="3121920"/>
                <a:ext cx="74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ZoneTexte 20"/>
              <p:cNvSpPr/>
              <p:nvPr/>
            </p:nvSpPr>
            <p:spPr>
              <a:xfrm>
                <a:off x="765000" y="41691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ZoneTexte 20"/>
              <p:cNvSpPr/>
              <p:nvPr/>
            </p:nvSpPr>
            <p:spPr>
              <a:xfrm>
                <a:off x="766440" y="408060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ZoneTexte 20"/>
              <p:cNvSpPr/>
              <p:nvPr/>
            </p:nvSpPr>
            <p:spPr>
              <a:xfrm>
                <a:off x="765000" y="39963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6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ZoneTexte 20"/>
              <p:cNvSpPr/>
              <p:nvPr/>
            </p:nvSpPr>
            <p:spPr>
              <a:xfrm>
                <a:off x="767880" y="42915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3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0" name="图片 3178" descr="电脑屏幕的照片&#10;&#10;低可信度描述已自动生成"/>
              <p:cNvPicPr/>
              <p:nvPr/>
            </p:nvPicPr>
            <p:blipFill>
              <a:blip r:embed="rId2"/>
              <a:srcRect l="10620" t="24344" r="11464" b="21079"/>
              <a:stretch/>
            </p:blipFill>
            <p:spPr>
              <a:xfrm>
                <a:off x="1158480" y="3434400"/>
                <a:ext cx="3233880" cy="1713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Connecteur droit 47"/>
              <p:cNvSpPr/>
              <p:nvPr/>
            </p:nvSpPr>
            <p:spPr>
              <a:xfrm>
                <a:off x="2091600" y="4041360"/>
                <a:ext cx="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Connecteur droit 47"/>
              <p:cNvSpPr/>
              <p:nvPr/>
            </p:nvSpPr>
            <p:spPr>
              <a:xfrm>
                <a:off x="2315520" y="4041360"/>
                <a:ext cx="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Connecteur droit 47"/>
              <p:cNvSpPr/>
              <p:nvPr/>
            </p:nvSpPr>
            <p:spPr>
              <a:xfrm>
                <a:off x="2553480" y="4041360"/>
                <a:ext cx="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ZoneTexte 100"/>
              <p:cNvSpPr/>
              <p:nvPr/>
            </p:nvSpPr>
            <p:spPr>
              <a:xfrm>
                <a:off x="4443840" y="3882600"/>
                <a:ext cx="1072800" cy="307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Retention of the first 140 bases of intron 1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Connecteur droit 47"/>
              <p:cNvSpPr/>
              <p:nvPr/>
            </p:nvSpPr>
            <p:spPr>
              <a:xfrm>
                <a:off x="3526560" y="4284360"/>
                <a:ext cx="0" cy="9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Connecteur droit 47"/>
              <p:cNvSpPr/>
              <p:nvPr/>
            </p:nvSpPr>
            <p:spPr>
              <a:xfrm>
                <a:off x="3044160" y="4282560"/>
                <a:ext cx="0" cy="9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Connecteur droit 47"/>
              <p:cNvSpPr/>
              <p:nvPr/>
            </p:nvSpPr>
            <p:spPr>
              <a:xfrm>
                <a:off x="3293280" y="4284360"/>
                <a:ext cx="0" cy="9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98" name="Connecteur droit avec flèche 49"/>
              <p:cNvCxnSpPr/>
              <p:nvPr/>
            </p:nvCxnSpPr>
            <p:spPr>
              <a:xfrm flipH="1">
                <a:off x="1856520" y="4151160"/>
                <a:ext cx="4356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99" name="Connecteur droit avec flèche 49"/>
              <p:cNvCxnSpPr/>
              <p:nvPr/>
            </p:nvCxnSpPr>
            <p:spPr>
              <a:xfrm flipH="1">
                <a:off x="2093040" y="4144320"/>
                <a:ext cx="46440" cy="6876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0" name="Connecteur droit avec flèche 49"/>
              <p:cNvCxnSpPr/>
              <p:nvPr/>
            </p:nvCxnSpPr>
            <p:spPr>
              <a:xfrm flipH="1">
                <a:off x="2340720" y="4144320"/>
                <a:ext cx="46440" cy="673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1" name="Connecteur droit avec flèche 49"/>
              <p:cNvCxnSpPr/>
              <p:nvPr/>
            </p:nvCxnSpPr>
            <p:spPr>
              <a:xfrm flipH="1">
                <a:off x="2577240" y="4144320"/>
                <a:ext cx="46440" cy="673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2" name="Connecteur droit avec flèche 49"/>
              <p:cNvCxnSpPr/>
              <p:nvPr/>
            </p:nvCxnSpPr>
            <p:spPr>
              <a:xfrm flipH="1">
                <a:off x="2821680" y="4139640"/>
                <a:ext cx="46440" cy="673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3" name="Connecteur droit avec flèche 49"/>
              <p:cNvCxnSpPr/>
              <p:nvPr/>
            </p:nvCxnSpPr>
            <p:spPr>
              <a:xfrm flipH="1">
                <a:off x="3021840" y="4141440"/>
                <a:ext cx="45000" cy="6876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4" name="Connecteur droit avec flèche 49"/>
              <p:cNvCxnSpPr/>
              <p:nvPr/>
            </p:nvCxnSpPr>
            <p:spPr>
              <a:xfrm flipH="1">
                <a:off x="3264840" y="4146120"/>
                <a:ext cx="45000" cy="673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5" name="Connecteur droit avec flèche 49"/>
              <p:cNvCxnSpPr/>
              <p:nvPr/>
            </p:nvCxnSpPr>
            <p:spPr>
              <a:xfrm flipH="1">
                <a:off x="3741120" y="4144320"/>
                <a:ext cx="46440" cy="673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06" name="Connecteur droit avec flèche 49"/>
              <p:cNvCxnSpPr/>
              <p:nvPr/>
            </p:nvCxnSpPr>
            <p:spPr>
              <a:xfrm flipH="1">
                <a:off x="3479040" y="4136400"/>
                <a:ext cx="46440" cy="6876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sp>
            <p:nvSpPr>
              <p:cNvPr id="107" name="Connecteur droit 4"/>
              <p:cNvSpPr/>
              <p:nvPr/>
            </p:nvSpPr>
            <p:spPr>
              <a:xfrm flipV="1">
                <a:off x="2092320" y="4036320"/>
                <a:ext cx="2351160" cy="4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Connecteur droit 134"/>
              <p:cNvSpPr/>
              <p:nvPr/>
            </p:nvSpPr>
            <p:spPr>
              <a:xfrm flipV="1">
                <a:off x="3033720" y="4381200"/>
                <a:ext cx="14112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ZoneTexte 100"/>
              <p:cNvSpPr/>
              <p:nvPr/>
            </p:nvSpPr>
            <p:spPr>
              <a:xfrm>
                <a:off x="4445280" y="4281120"/>
                <a:ext cx="855360" cy="2005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xon 2 skipped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0" name="组合 3243"/>
            <p:cNvGrpSpPr/>
            <p:nvPr/>
          </p:nvGrpSpPr>
          <p:grpSpPr>
            <a:xfrm>
              <a:off x="836640" y="5319720"/>
              <a:ext cx="4527720" cy="2398680"/>
              <a:chOff x="836640" y="5319720"/>
              <a:chExt cx="4527720" cy="2398680"/>
            </a:xfrm>
          </p:grpSpPr>
          <p:sp>
            <p:nvSpPr>
              <p:cNvPr id="111" name="ZoneTexte 12"/>
              <p:cNvSpPr/>
              <p:nvPr/>
            </p:nvSpPr>
            <p:spPr>
              <a:xfrm rot="19360800">
                <a:off x="1416960" y="5527440"/>
                <a:ext cx="74916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ZoneTexte 12"/>
              <p:cNvSpPr/>
              <p:nvPr/>
            </p:nvSpPr>
            <p:spPr>
              <a:xfrm rot="19360800">
                <a:off x="1913400" y="55598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4A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ZoneTexte 12"/>
              <p:cNvSpPr/>
              <p:nvPr/>
            </p:nvSpPr>
            <p:spPr>
              <a:xfrm rot="19360800">
                <a:off x="2129400" y="55533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4A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ZoneTexte 12"/>
              <p:cNvSpPr/>
              <p:nvPr/>
            </p:nvSpPr>
            <p:spPr>
              <a:xfrm rot="19360800">
                <a:off x="2381760" y="55598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4A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ZoneTexte 12"/>
              <p:cNvSpPr/>
              <p:nvPr/>
            </p:nvSpPr>
            <p:spPr>
              <a:xfrm rot="19360800">
                <a:off x="2621520" y="55533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5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ZoneTexte 12"/>
              <p:cNvSpPr/>
              <p:nvPr/>
            </p:nvSpPr>
            <p:spPr>
              <a:xfrm rot="19360800">
                <a:off x="2856600" y="5546880"/>
                <a:ext cx="587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6A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ZoneTexte 12"/>
              <p:cNvSpPr/>
              <p:nvPr/>
            </p:nvSpPr>
            <p:spPr>
              <a:xfrm rot="19360800">
                <a:off x="3087720" y="553932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6A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ZoneTexte 12"/>
              <p:cNvSpPr/>
              <p:nvPr/>
            </p:nvSpPr>
            <p:spPr>
              <a:xfrm rot="19360800">
                <a:off x="3326760" y="555480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6A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ZoneTexte 12"/>
              <p:cNvSpPr/>
              <p:nvPr/>
            </p:nvSpPr>
            <p:spPr>
              <a:xfrm rot="19360800">
                <a:off x="3596760" y="5509440"/>
                <a:ext cx="74592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mpty vecto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ZoneTexte 12"/>
              <p:cNvSpPr/>
              <p:nvPr/>
            </p:nvSpPr>
            <p:spPr>
              <a:xfrm rot="19360800">
                <a:off x="1663920" y="5559480"/>
                <a:ext cx="66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Wild-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ZoneTexte 20"/>
              <p:cNvSpPr/>
              <p:nvPr/>
            </p:nvSpPr>
            <p:spPr>
              <a:xfrm>
                <a:off x="836640" y="71049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ZoneTexte 20"/>
              <p:cNvSpPr/>
              <p:nvPr/>
            </p:nvSpPr>
            <p:spPr>
              <a:xfrm>
                <a:off x="836640" y="72219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ZoneTexte 20"/>
              <p:cNvSpPr/>
              <p:nvPr/>
            </p:nvSpPr>
            <p:spPr>
              <a:xfrm>
                <a:off x="836640" y="738432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3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ZoneTexte 20"/>
              <p:cNvSpPr/>
              <p:nvPr/>
            </p:nvSpPr>
            <p:spPr>
              <a:xfrm>
                <a:off x="838080" y="69951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6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25" name="图片 3212" descr="电脑屏幕的照片&#10;&#10;低可信度描述已自动生成"/>
              <p:cNvPicPr/>
              <p:nvPr/>
            </p:nvPicPr>
            <p:blipFill>
              <a:blip r:embed="rId3"/>
              <a:srcRect l="10447" t="10663" r="10136" b="30988"/>
              <a:stretch/>
            </p:blipFill>
            <p:spPr>
              <a:xfrm>
                <a:off x="1229760" y="5853960"/>
                <a:ext cx="3354480" cy="1864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6" name="标注: 线形 114"/>
              <p:cNvSpPr/>
              <p:nvPr/>
            </p:nvSpPr>
            <p:spPr>
              <a:xfrm>
                <a:off x="4596120" y="7361280"/>
                <a:ext cx="699840" cy="133200"/>
              </a:xfrm>
              <a:prstGeom prst="borderCallout1">
                <a:avLst>
                  <a:gd name="adj1" fmla="val 18750"/>
                  <a:gd name="adj2" fmla="val -8333"/>
                  <a:gd name="adj3" fmla="val 50574"/>
                  <a:gd name="adj4" fmla="val -305064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Connecteur droit 47"/>
              <p:cNvSpPr/>
              <p:nvPr/>
            </p:nvSpPr>
            <p:spPr>
              <a:xfrm>
                <a:off x="3672720" y="736128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ZoneTexte 100"/>
              <p:cNvSpPr/>
              <p:nvPr/>
            </p:nvSpPr>
            <p:spPr>
              <a:xfrm>
                <a:off x="4551840" y="7323120"/>
                <a:ext cx="812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xon 2 skipped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Connecteur droit 47"/>
              <p:cNvSpPr/>
              <p:nvPr/>
            </p:nvSpPr>
            <p:spPr>
              <a:xfrm>
                <a:off x="3386880" y="736128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Connecteur droit 47"/>
              <p:cNvSpPr/>
              <p:nvPr/>
            </p:nvSpPr>
            <p:spPr>
              <a:xfrm>
                <a:off x="2463840" y="736128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31" name="Connecteur droit avec flèche 49"/>
              <p:cNvCxnSpPr/>
              <p:nvPr/>
            </p:nvCxnSpPr>
            <p:spPr>
              <a:xfrm flipH="1">
                <a:off x="2255040" y="7188120"/>
                <a:ext cx="4356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2" name="Connecteur droit avec flèche 49"/>
              <p:cNvCxnSpPr/>
              <p:nvPr/>
            </p:nvCxnSpPr>
            <p:spPr>
              <a:xfrm flipH="1">
                <a:off x="2475720" y="7189920"/>
                <a:ext cx="4356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3" name="Connecteur droit avec flèche 49"/>
              <p:cNvCxnSpPr/>
              <p:nvPr/>
            </p:nvCxnSpPr>
            <p:spPr>
              <a:xfrm flipH="1">
                <a:off x="2701440" y="718992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4" name="Connecteur droit avec flèche 49"/>
              <p:cNvCxnSpPr/>
              <p:nvPr/>
            </p:nvCxnSpPr>
            <p:spPr>
              <a:xfrm flipH="1">
                <a:off x="2925000" y="718992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5" name="Connecteur droit avec flèche 49"/>
              <p:cNvCxnSpPr/>
              <p:nvPr/>
            </p:nvCxnSpPr>
            <p:spPr>
              <a:xfrm flipH="1">
                <a:off x="3177720" y="719136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6" name="Connecteur droit avec flèche 49"/>
              <p:cNvCxnSpPr/>
              <p:nvPr/>
            </p:nvCxnSpPr>
            <p:spPr>
              <a:xfrm flipH="1">
                <a:off x="3409200" y="720252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7" name="Connecteur droit avec flèche 49"/>
              <p:cNvCxnSpPr/>
              <p:nvPr/>
            </p:nvCxnSpPr>
            <p:spPr>
              <a:xfrm flipH="1">
                <a:off x="2021760" y="718992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38" name="Connecteur droit avec flèche 49"/>
              <p:cNvCxnSpPr/>
              <p:nvPr/>
            </p:nvCxnSpPr>
            <p:spPr>
              <a:xfrm flipH="1">
                <a:off x="3641040" y="7200720"/>
                <a:ext cx="45000" cy="673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</p:grpSp>
        <p:sp>
          <p:nvSpPr>
            <p:cNvPr id="139" name="ZoneTexte 91"/>
            <p:cNvSpPr/>
            <p:nvPr/>
          </p:nvSpPr>
          <p:spPr>
            <a:xfrm>
              <a:off x="2247840" y="7678800"/>
              <a:ext cx="1468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</a:rPr>
                <a:t>To be continued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ZoneTexte 92"/>
            <p:cNvSpPr/>
            <p:nvPr/>
          </p:nvSpPr>
          <p:spPr>
            <a:xfrm>
              <a:off x="1463040" y="8129880"/>
              <a:ext cx="281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Figure S1.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ull-length gel images for Figure 6.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e 1"/>
          <p:cNvGrpSpPr/>
          <p:nvPr/>
        </p:nvGrpSpPr>
        <p:grpSpPr>
          <a:xfrm>
            <a:off x="836640" y="399960"/>
            <a:ext cx="4506840" cy="4975200"/>
            <a:chOff x="836640" y="399960"/>
            <a:chExt cx="4506840" cy="4975200"/>
          </a:xfrm>
        </p:grpSpPr>
        <p:grpSp>
          <p:nvGrpSpPr>
            <p:cNvPr id="142" name="组合 2"/>
            <p:cNvGrpSpPr/>
            <p:nvPr/>
          </p:nvGrpSpPr>
          <p:grpSpPr>
            <a:xfrm>
              <a:off x="836640" y="399960"/>
              <a:ext cx="4506840" cy="2268720"/>
              <a:chOff x="836640" y="399960"/>
              <a:chExt cx="4506840" cy="2268720"/>
            </a:xfrm>
          </p:grpSpPr>
          <p:sp>
            <p:nvSpPr>
              <p:cNvPr id="143" name="ZoneTexte 12"/>
              <p:cNvSpPr/>
              <p:nvPr/>
            </p:nvSpPr>
            <p:spPr>
              <a:xfrm rot="19360800">
                <a:off x="3600720" y="589680"/>
                <a:ext cx="74592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mpty vecto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ZoneTexte 12"/>
              <p:cNvSpPr/>
              <p:nvPr/>
            </p:nvSpPr>
            <p:spPr>
              <a:xfrm rot="19360800">
                <a:off x="1929240" y="64620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7G&gt;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ZoneTexte 12"/>
              <p:cNvSpPr/>
              <p:nvPr/>
            </p:nvSpPr>
            <p:spPr>
              <a:xfrm rot="19360800">
                <a:off x="2165760" y="6429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7G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ZoneTexte 12"/>
              <p:cNvSpPr/>
              <p:nvPr/>
            </p:nvSpPr>
            <p:spPr>
              <a:xfrm rot="19360800">
                <a:off x="2405520" y="642960"/>
                <a:ext cx="587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7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ZoneTexte 12"/>
              <p:cNvSpPr/>
              <p:nvPr/>
            </p:nvSpPr>
            <p:spPr>
              <a:xfrm rot="19360800">
                <a:off x="2651760" y="64296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8G&gt;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ZoneTexte 12"/>
              <p:cNvSpPr/>
              <p:nvPr/>
            </p:nvSpPr>
            <p:spPr>
              <a:xfrm rot="19360800">
                <a:off x="2894760" y="6494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8G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ZoneTexte 12"/>
              <p:cNvSpPr/>
              <p:nvPr/>
            </p:nvSpPr>
            <p:spPr>
              <a:xfrm rot="19360800">
                <a:off x="3134520" y="649440"/>
                <a:ext cx="585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c.88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ZoneTexte 12"/>
              <p:cNvSpPr/>
              <p:nvPr/>
            </p:nvSpPr>
            <p:spPr>
              <a:xfrm rot="19360800">
                <a:off x="3384720" y="677160"/>
                <a:ext cx="587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178T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ZoneTexte 12"/>
              <p:cNvSpPr/>
              <p:nvPr/>
            </p:nvSpPr>
            <p:spPr>
              <a:xfrm rot="19360800">
                <a:off x="1447560" y="608040"/>
                <a:ext cx="74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ZoneTexte 20"/>
              <p:cNvSpPr/>
              <p:nvPr/>
            </p:nvSpPr>
            <p:spPr>
              <a:xfrm>
                <a:off x="836640" y="18939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ZoneTexte 20"/>
              <p:cNvSpPr/>
              <p:nvPr/>
            </p:nvSpPr>
            <p:spPr>
              <a:xfrm>
                <a:off x="836640" y="173988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6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ZoneTexte 20"/>
              <p:cNvSpPr/>
              <p:nvPr/>
            </p:nvSpPr>
            <p:spPr>
              <a:xfrm>
                <a:off x="836640" y="182088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ZoneTexte 12"/>
              <p:cNvSpPr/>
              <p:nvPr/>
            </p:nvSpPr>
            <p:spPr>
              <a:xfrm rot="19360800">
                <a:off x="1710360" y="646200"/>
                <a:ext cx="66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Wild-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56" name="图片 28" descr="文本&#10;&#10;低可信度描述已自动生成"/>
              <p:cNvPicPr/>
              <p:nvPr/>
            </p:nvPicPr>
            <p:blipFill>
              <a:blip r:embed="rId1"/>
              <a:srcRect l="8586" t="15272" r="12010" b="31102"/>
              <a:stretch/>
            </p:blipFill>
            <p:spPr>
              <a:xfrm>
                <a:off x="1230120" y="971280"/>
                <a:ext cx="3321000" cy="1697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7" name="标注: 线形 3144"/>
              <p:cNvSpPr/>
              <p:nvPr/>
            </p:nvSpPr>
            <p:spPr>
              <a:xfrm>
                <a:off x="4573800" y="1976400"/>
                <a:ext cx="699840" cy="134640"/>
              </a:xfrm>
              <a:prstGeom prst="borderCallout1">
                <a:avLst>
                  <a:gd name="adj1" fmla="val 18750"/>
                  <a:gd name="adj2" fmla="val -8333"/>
                  <a:gd name="adj3" fmla="val 55310"/>
                  <a:gd name="adj4" fmla="val -331037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ZoneTexte 100"/>
              <p:cNvSpPr/>
              <p:nvPr/>
            </p:nvSpPr>
            <p:spPr>
              <a:xfrm>
                <a:off x="4530960" y="1941480"/>
                <a:ext cx="812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xon 2 skipped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Connecteur droit 47"/>
              <p:cNvSpPr/>
              <p:nvPr/>
            </p:nvSpPr>
            <p:spPr>
              <a:xfrm>
                <a:off x="2727360" y="1979640"/>
                <a:ext cx="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Connecteur droit 47"/>
              <p:cNvSpPr/>
              <p:nvPr/>
            </p:nvSpPr>
            <p:spPr>
              <a:xfrm>
                <a:off x="2463840" y="19764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Connecteur droit 47"/>
              <p:cNvSpPr/>
              <p:nvPr/>
            </p:nvSpPr>
            <p:spPr>
              <a:xfrm>
                <a:off x="2247840" y="19764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62" name="Connecteur droit avec flèche 49"/>
              <p:cNvCxnSpPr/>
              <p:nvPr/>
            </p:nvCxnSpPr>
            <p:spPr>
              <a:xfrm flipH="1">
                <a:off x="2923560" y="1836720"/>
                <a:ext cx="4356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63" name="Connecteur droit avec flèche 49"/>
              <p:cNvCxnSpPr/>
              <p:nvPr/>
            </p:nvCxnSpPr>
            <p:spPr>
              <a:xfrm flipH="1">
                <a:off x="3183840" y="183672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64" name="Connecteur droit avec flèche 49"/>
              <p:cNvCxnSpPr/>
              <p:nvPr/>
            </p:nvCxnSpPr>
            <p:spPr>
              <a:xfrm flipH="1">
                <a:off x="3399840" y="183348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65" name="Connecteur droit avec flèche 49"/>
              <p:cNvCxnSpPr/>
              <p:nvPr/>
            </p:nvCxnSpPr>
            <p:spPr>
              <a:xfrm flipH="1">
                <a:off x="2031120" y="1838520"/>
                <a:ext cx="4356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66" name="Connecteur droit avec flèche 49"/>
              <p:cNvCxnSpPr/>
              <p:nvPr/>
            </p:nvCxnSpPr>
            <p:spPr>
              <a:xfrm flipH="1">
                <a:off x="3642480" y="183672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</p:grpSp>
        <p:grpSp>
          <p:nvGrpSpPr>
            <p:cNvPr id="167" name="组合 1"/>
            <p:cNvGrpSpPr/>
            <p:nvPr/>
          </p:nvGrpSpPr>
          <p:grpSpPr>
            <a:xfrm>
              <a:off x="907920" y="3067560"/>
              <a:ext cx="3645000" cy="2307600"/>
              <a:chOff x="907920" y="3067560"/>
              <a:chExt cx="3645000" cy="2307600"/>
            </a:xfrm>
          </p:grpSpPr>
          <p:pic>
            <p:nvPicPr>
              <p:cNvPr id="168" name="图片 69" descr="电脑屏幕的照片&#10;&#10;低可信度描述已自动生成"/>
              <p:cNvPicPr/>
              <p:nvPr/>
            </p:nvPicPr>
            <p:blipFill>
              <a:blip r:embed="rId2"/>
              <a:srcRect l="12593" t="23753" r="10298" b="20472"/>
              <a:stretch/>
            </p:blipFill>
            <p:spPr>
              <a:xfrm>
                <a:off x="1285560" y="3587760"/>
                <a:ext cx="3267360" cy="1787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9" name="ZoneTexte 12"/>
              <p:cNvSpPr/>
              <p:nvPr/>
            </p:nvSpPr>
            <p:spPr>
              <a:xfrm rot="19360800">
                <a:off x="1976400" y="3287520"/>
                <a:ext cx="720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194G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ZoneTexte 12"/>
              <p:cNvSpPr/>
              <p:nvPr/>
            </p:nvSpPr>
            <p:spPr>
              <a:xfrm rot="19360800">
                <a:off x="2226960" y="3320640"/>
                <a:ext cx="587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194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ZoneTexte 12"/>
              <p:cNvSpPr/>
              <p:nvPr/>
            </p:nvSpPr>
            <p:spPr>
              <a:xfrm rot="19360800">
                <a:off x="2921400" y="3322080"/>
                <a:ext cx="585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195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ZoneTexte 12"/>
              <p:cNvSpPr/>
              <p:nvPr/>
            </p:nvSpPr>
            <p:spPr>
              <a:xfrm rot="19360800">
                <a:off x="3106800" y="3268080"/>
                <a:ext cx="745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mpty vecto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ZoneTexte 12"/>
              <p:cNvSpPr/>
              <p:nvPr/>
            </p:nvSpPr>
            <p:spPr>
              <a:xfrm rot="19360800">
                <a:off x="1506600" y="3258360"/>
                <a:ext cx="74772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ZoneTexte 12"/>
              <p:cNvSpPr/>
              <p:nvPr/>
            </p:nvSpPr>
            <p:spPr>
              <a:xfrm rot="19360800">
                <a:off x="1716840" y="3299040"/>
                <a:ext cx="662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Wild-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ZoneTexte 12"/>
              <p:cNvSpPr/>
              <p:nvPr/>
            </p:nvSpPr>
            <p:spPr>
              <a:xfrm rot="19360800">
                <a:off x="2682720" y="3285720"/>
                <a:ext cx="718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195G&gt;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ZoneTexte 12"/>
              <p:cNvSpPr/>
              <p:nvPr/>
            </p:nvSpPr>
            <p:spPr>
              <a:xfrm rot="19360800">
                <a:off x="2465280" y="3322080"/>
                <a:ext cx="587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195G&gt;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ZoneTexte 20"/>
              <p:cNvSpPr/>
              <p:nvPr/>
            </p:nvSpPr>
            <p:spPr>
              <a:xfrm>
                <a:off x="907920" y="4183200"/>
                <a:ext cx="619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ZoneTexte 20"/>
              <p:cNvSpPr/>
              <p:nvPr/>
            </p:nvSpPr>
            <p:spPr>
              <a:xfrm>
                <a:off x="907920" y="4249800"/>
                <a:ext cx="619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ZoneTexte 20"/>
              <p:cNvSpPr/>
              <p:nvPr/>
            </p:nvSpPr>
            <p:spPr>
              <a:xfrm>
                <a:off x="907920" y="4116240"/>
                <a:ext cx="619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6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80" name="Connecteur droit avec flèche 49"/>
              <p:cNvCxnSpPr/>
              <p:nvPr/>
            </p:nvCxnSpPr>
            <p:spPr>
              <a:xfrm flipH="1">
                <a:off x="2750400" y="421632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1" name="Connecteur droit avec flèche 49"/>
              <p:cNvCxnSpPr/>
              <p:nvPr/>
            </p:nvCxnSpPr>
            <p:spPr>
              <a:xfrm flipH="1">
                <a:off x="2967840" y="4216320"/>
                <a:ext cx="4356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2" name="Connecteur droit avec flèche 49"/>
              <p:cNvCxnSpPr/>
              <p:nvPr/>
            </p:nvCxnSpPr>
            <p:spPr>
              <a:xfrm flipH="1">
                <a:off x="3204360" y="421488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3" name="Connecteur droit avec flèche 49"/>
              <p:cNvCxnSpPr/>
              <p:nvPr/>
            </p:nvCxnSpPr>
            <p:spPr>
              <a:xfrm flipH="1">
                <a:off x="2037600" y="422100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4" name="Connecteur droit avec flèche 49"/>
              <p:cNvCxnSpPr/>
              <p:nvPr/>
            </p:nvCxnSpPr>
            <p:spPr>
              <a:xfrm flipH="1">
                <a:off x="2297880" y="422100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5" name="Connecteur droit avec flèche 49"/>
              <p:cNvCxnSpPr/>
              <p:nvPr/>
            </p:nvCxnSpPr>
            <p:spPr>
              <a:xfrm flipH="1">
                <a:off x="2513880" y="422100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09T13:46:12Z</dcterms:created>
  <dc:creator>recherche20</dc:creator>
  <dc:description/>
  <dc:language>en-US</dc:language>
  <cp:lastModifiedBy>user</cp:lastModifiedBy>
  <cp:lastPrinted>2020-11-24T10:26:10Z</cp:lastPrinted>
  <dcterms:modified xsi:type="dcterms:W3CDTF">2024-02-09T08:55:52Z</dcterms:modified>
  <cp:revision>658</cp:revision>
  <dc:subject/>
  <dc:title>Diapositive 1</dc:title>
</cp:coreProperties>
</file>